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34: </a:t>
            </a:r>
            <a:r>
              <a:rPr lang="en-GB" sz="1600" dirty="0" smtClean="0"/>
              <a:t>3D model structure and validation of</a:t>
            </a:r>
            <a:r>
              <a:rPr lang="en-US" sz="1600" dirty="0" smtClean="0"/>
              <a:t>PIK3CA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4ykn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4ykn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00034" y="142852"/>
            <a:ext cx="3286148" cy="2731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86380" y="142852"/>
            <a:ext cx="3554412" cy="2857520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0034" y="3170278"/>
            <a:ext cx="3286148" cy="28114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76880" y="3143248"/>
            <a:ext cx="3581400" cy="2852739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78</cp:revision>
  <dcterms:created xsi:type="dcterms:W3CDTF">2018-05-10T07:33:24Z</dcterms:created>
  <dcterms:modified xsi:type="dcterms:W3CDTF">2018-05-29T07:38:10Z</dcterms:modified>
</cp:coreProperties>
</file>